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handoutMasterIdLst>
    <p:handoutMasterId r:id="rId11"/>
  </p:handoutMasterIdLst>
  <p:sldIdLst>
    <p:sldId id="256" r:id="rId2"/>
    <p:sldId id="264" r:id="rId3"/>
    <p:sldId id="257" r:id="rId4"/>
    <p:sldId id="259" r:id="rId5"/>
    <p:sldId id="261" r:id="rId6"/>
    <p:sldId id="262" r:id="rId7"/>
    <p:sldId id="258" r:id="rId8"/>
    <p:sldId id="265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3" clrMode="gray" frameSlides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714" y="6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8" d="100"/>
        <a:sy n="128" d="100"/>
      </p:scale>
      <p:origin x="0" y="376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E28A42-539C-8C42-9684-4F241359A9BC}" type="datetimeFigureOut">
              <a:rPr lang="en-US" smtClean="0"/>
              <a:t>9/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A713B0-AA2B-8540-86B3-52B614AB0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78097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73B413-F023-428B-B1F2-9C44477C4DA8}" type="datetimeFigureOut">
              <a:rPr lang="zh-CN" altLang="en-US" smtClean="0"/>
              <a:t>2017/9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3B58F7-F6A4-4241-BB41-4300024197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02519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6D2DA35-227F-E347-8B68-CE62BDEFEB5E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52085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CCD58-F3AF-4D17-AC20-F4AE69360C62}" type="datetimeFigureOut">
              <a:rPr lang="zh-CN" altLang="en-US" smtClean="0"/>
              <a:t>2017/9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3870A-94A7-4029-B368-9426A4DA16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39994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CCD58-F3AF-4D17-AC20-F4AE69360C62}" type="datetimeFigureOut">
              <a:rPr lang="zh-CN" altLang="en-US" smtClean="0"/>
              <a:t>2017/9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3870A-94A7-4029-B368-9426A4DA16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9770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CCD58-F3AF-4D17-AC20-F4AE69360C62}" type="datetimeFigureOut">
              <a:rPr lang="zh-CN" altLang="en-US" smtClean="0"/>
              <a:t>2017/9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3870A-94A7-4029-B368-9426A4DA16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4878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CCD58-F3AF-4D17-AC20-F4AE69360C62}" type="datetimeFigureOut">
              <a:rPr lang="zh-CN" altLang="en-US" smtClean="0"/>
              <a:t>2017/9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3870A-94A7-4029-B368-9426A4DA16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41299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CCD58-F3AF-4D17-AC20-F4AE69360C62}" type="datetimeFigureOut">
              <a:rPr lang="zh-CN" altLang="en-US" smtClean="0"/>
              <a:t>2017/9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3870A-94A7-4029-B368-9426A4DA16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5516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CCD58-F3AF-4D17-AC20-F4AE69360C62}" type="datetimeFigureOut">
              <a:rPr lang="zh-CN" altLang="en-US" smtClean="0"/>
              <a:t>2017/9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3870A-94A7-4029-B368-9426A4DA16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21668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CCD58-F3AF-4D17-AC20-F4AE69360C62}" type="datetimeFigureOut">
              <a:rPr lang="zh-CN" altLang="en-US" smtClean="0"/>
              <a:t>2017/9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3870A-94A7-4029-B368-9426A4DA16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22390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CCD58-F3AF-4D17-AC20-F4AE69360C62}" type="datetimeFigureOut">
              <a:rPr lang="zh-CN" altLang="en-US" smtClean="0"/>
              <a:t>2017/9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3870A-94A7-4029-B368-9426A4DA16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7535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CCD58-F3AF-4D17-AC20-F4AE69360C62}" type="datetimeFigureOut">
              <a:rPr lang="zh-CN" altLang="en-US" smtClean="0"/>
              <a:t>2017/9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3870A-94A7-4029-B368-9426A4DA16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21708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CCD58-F3AF-4D17-AC20-F4AE69360C62}" type="datetimeFigureOut">
              <a:rPr lang="zh-CN" altLang="en-US" smtClean="0"/>
              <a:t>2017/9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3870A-94A7-4029-B368-9426A4DA16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49073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CCD58-F3AF-4D17-AC20-F4AE69360C62}" type="datetimeFigureOut">
              <a:rPr lang="zh-CN" altLang="en-US" smtClean="0"/>
              <a:t>2017/9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3870A-94A7-4029-B368-9426A4DA16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41156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3CCD58-F3AF-4D17-AC20-F4AE69360C62}" type="datetimeFigureOut">
              <a:rPr lang="zh-CN" altLang="en-US" smtClean="0"/>
              <a:t>2017/9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73870A-94A7-4029-B368-9426A4DA16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08893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.tif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261745" y="382137"/>
            <a:ext cx="11701523" cy="6077147"/>
            <a:chOff x="289041" y="109182"/>
            <a:chExt cx="11701523" cy="6077147"/>
          </a:xfrm>
        </p:grpSpPr>
        <p:sp>
          <p:nvSpPr>
            <p:cNvPr id="2" name="TextBox 1"/>
            <p:cNvSpPr txBox="1"/>
            <p:nvPr/>
          </p:nvSpPr>
          <p:spPr>
            <a:xfrm>
              <a:off x="289041" y="4986000"/>
              <a:ext cx="11701523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.S1</a:t>
              </a:r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Cell 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poptosis assay of HK-2 was assessed by ﬂow cytometry analysis. HK-2 cells treated with 0, 1, 10, 50 µM of </a:t>
              </a:r>
              <a:r>
                <a:rPr lang="en-US" altLang="zh-CN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zoledronate</a:t>
              </a:r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for 48 h were stained with </a:t>
              </a:r>
              <a:r>
                <a:rPr lang="en-US" dirty="0" err="1">
                  <a:latin typeface="Arial" panose="020B0604020202020204" pitchFamily="34" charset="0"/>
                  <a:cs typeface="Arial" panose="020B0604020202020204" pitchFamily="34" charset="0"/>
                </a:rPr>
                <a:t>Annexin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-PI for the determination of frequency of apoptosis. The right lower quadrant and the right upper quadrant represents the early stage of apoptosis and end stage of apoptosis/necrosis, respectively. </a:t>
              </a:r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Transcriptional regulation of mRNA levels of apoptotic and kidney injury genes. </a:t>
              </a:r>
            </a:p>
          </p:txBody>
        </p:sp>
        <p:pic>
          <p:nvPicPr>
            <p:cNvPr id="5" name="内容占位符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55908" y="635866"/>
              <a:ext cx="5278465" cy="3608587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5343" y="127672"/>
              <a:ext cx="4517410" cy="4733609"/>
            </a:xfrm>
            <a:prstGeom prst="rect">
              <a:avLst/>
            </a:prstGeom>
          </p:spPr>
        </p:pic>
        <p:sp>
          <p:nvSpPr>
            <p:cNvPr id="6" name="文本框 5"/>
            <p:cNvSpPr txBox="1"/>
            <p:nvPr/>
          </p:nvSpPr>
          <p:spPr>
            <a:xfrm>
              <a:off x="668740" y="109182"/>
              <a:ext cx="596509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                                                                b</a:t>
              </a:r>
              <a:endParaRPr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142043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16" t="674" r="11409" b="1469"/>
          <a:stretch/>
        </p:blipFill>
        <p:spPr>
          <a:xfrm>
            <a:off x="3684896" y="354840"/>
            <a:ext cx="4585648" cy="4258103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2587504" y="5332203"/>
            <a:ext cx="699322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Categories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f significantly changed proteins analyzed by KOBAS database (Peking University, Beijing, China).</a:t>
            </a:r>
          </a:p>
        </p:txBody>
      </p:sp>
    </p:spTree>
    <p:extLst>
      <p:ext uri="{BB962C8B-B14F-4D97-AF65-F5344CB8AC3E}">
        <p14:creationId xmlns:p14="http://schemas.microsoft.com/office/powerpoint/2010/main" val="24032737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828902" y="4874350"/>
            <a:ext cx="1089452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S3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estern blot analyses of TGFβ-SMAD3 signaling and fibrosis marker in th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HEK293T(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nd NRK-52E cell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fter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zoledronate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treatments.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Effect of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zoledronate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treatment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n inflammation markers. 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组合 11"/>
          <p:cNvGrpSpPr/>
          <p:nvPr/>
        </p:nvGrpSpPr>
        <p:grpSpPr>
          <a:xfrm>
            <a:off x="983206" y="787666"/>
            <a:ext cx="10644687" cy="3878832"/>
            <a:chOff x="983206" y="787666"/>
            <a:chExt cx="10644687" cy="3878832"/>
          </a:xfrm>
        </p:grpSpPr>
        <p:sp>
          <p:nvSpPr>
            <p:cNvPr id="5" name="文本框 7"/>
            <p:cNvSpPr txBox="1"/>
            <p:nvPr/>
          </p:nvSpPr>
          <p:spPr>
            <a:xfrm>
              <a:off x="1917236" y="986240"/>
              <a:ext cx="184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1184882" y="787666"/>
              <a:ext cx="8832575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2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                b                                           c</a:t>
              </a:r>
              <a:r>
                <a:rPr lang="en-US" sz="3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</a:t>
              </a:r>
              <a:endParaRPr lang="en-US" sz="3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83206" y="1323833"/>
              <a:ext cx="3814075" cy="3269207"/>
            </a:xfrm>
            <a:prstGeom prst="rect">
              <a:avLst/>
            </a:prstGeom>
          </p:spPr>
        </p:pic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11492" y="1282889"/>
              <a:ext cx="3352326" cy="3269207"/>
            </a:xfrm>
            <a:prstGeom prst="rect">
              <a:avLst/>
            </a:prstGeom>
          </p:spPr>
        </p:pic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79975" y="1763096"/>
              <a:ext cx="2947918" cy="290340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1116129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41194" y="4731631"/>
            <a:ext cx="11354937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S4 a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No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ignificant alteration in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reatinine secretion in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zoledronate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reated mice compared with control group for 2-week (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Quantification of TGFβ1 in supernatant of HK-2 cells with or without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zoledronate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Quantification of TGFβ1 i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mouse serums treated or untreated with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zoledronate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b="1" dirty="0" smtClean="0"/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ffect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zoledronate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reatment on inflammation markers.  </a:t>
            </a:r>
          </a:p>
          <a:p>
            <a:pPr algn="just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614167" y="1070629"/>
            <a:ext cx="10943939" cy="3513995"/>
            <a:chOff x="614167" y="1070629"/>
            <a:chExt cx="10943939" cy="3513995"/>
          </a:xfrm>
        </p:grpSpPr>
        <p:grpSp>
          <p:nvGrpSpPr>
            <p:cNvPr id="6" name="组合 5"/>
            <p:cNvGrpSpPr/>
            <p:nvPr/>
          </p:nvGrpSpPr>
          <p:grpSpPr>
            <a:xfrm>
              <a:off x="614167" y="1070629"/>
              <a:ext cx="10943939" cy="3513995"/>
              <a:chOff x="614167" y="1070629"/>
              <a:chExt cx="10943939" cy="3513995"/>
            </a:xfrm>
          </p:grpSpPr>
          <p:grpSp>
            <p:nvGrpSpPr>
              <p:cNvPr id="15" name="组合 14"/>
              <p:cNvGrpSpPr/>
              <p:nvPr/>
            </p:nvGrpSpPr>
            <p:grpSpPr>
              <a:xfrm>
                <a:off x="614167" y="1070629"/>
                <a:ext cx="10943939" cy="3230180"/>
                <a:chOff x="614167" y="1070629"/>
                <a:chExt cx="10943939" cy="3230180"/>
              </a:xfrm>
            </p:grpSpPr>
            <p:pic>
              <p:nvPicPr>
                <p:cNvPr id="9" name="图片 8"/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73146" y="1684421"/>
                  <a:ext cx="2490697" cy="2616388"/>
                </a:xfrm>
                <a:prstGeom prst="rect">
                  <a:avLst/>
                </a:prstGeom>
              </p:spPr>
            </p:pic>
            <p:sp>
              <p:nvSpPr>
                <p:cNvPr id="3" name="Rectangle 2"/>
                <p:cNvSpPr/>
                <p:nvPr/>
              </p:nvSpPr>
              <p:spPr>
                <a:xfrm>
                  <a:off x="3344037" y="1094534"/>
                  <a:ext cx="372668" cy="461665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24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 </a:t>
                  </a:r>
                  <a:endParaRPr lang="en-US" sz="2400" dirty="0"/>
                </a:p>
              </p:txBody>
            </p:sp>
            <p:sp>
              <p:nvSpPr>
                <p:cNvPr id="8" name="Rectangle 7"/>
                <p:cNvSpPr/>
                <p:nvPr/>
              </p:nvSpPr>
              <p:spPr>
                <a:xfrm>
                  <a:off x="614167" y="1070629"/>
                  <a:ext cx="355837" cy="461665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24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a </a:t>
                  </a:r>
                  <a:endParaRPr lang="en-US" sz="2400" dirty="0"/>
                </a:p>
              </p:txBody>
            </p:sp>
            <p:sp>
              <p:nvSpPr>
                <p:cNvPr id="10" name="Rectangle 9"/>
                <p:cNvSpPr/>
                <p:nvPr/>
              </p:nvSpPr>
              <p:spPr>
                <a:xfrm>
                  <a:off x="6099609" y="1083677"/>
                  <a:ext cx="355837" cy="461665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24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 </a:t>
                  </a:r>
                  <a:endParaRPr lang="en-US" sz="2400" dirty="0"/>
                </a:p>
              </p:txBody>
            </p:sp>
            <p:sp>
              <p:nvSpPr>
                <p:cNvPr id="11" name="Rectangle 10"/>
                <p:cNvSpPr/>
                <p:nvPr/>
              </p:nvSpPr>
              <p:spPr>
                <a:xfrm>
                  <a:off x="8722058" y="1090664"/>
                  <a:ext cx="273496" cy="830997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24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d </a:t>
                  </a:r>
                  <a:endParaRPr lang="en-US" sz="2400" dirty="0"/>
                </a:p>
              </p:txBody>
            </p:sp>
            <p:pic>
              <p:nvPicPr>
                <p:cNvPr id="13" name="图片 12"/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007522" y="1441285"/>
                  <a:ext cx="2550584" cy="2838244"/>
                </a:xfrm>
                <a:prstGeom prst="rect">
                  <a:avLst/>
                </a:prstGeom>
              </p:spPr>
            </p:pic>
          </p:grpSp>
          <p:pic>
            <p:nvPicPr>
              <p:cNvPr id="4" name="图片 3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876863" y="1351128"/>
                <a:ext cx="2036301" cy="3233496"/>
              </a:xfrm>
              <a:prstGeom prst="rect">
                <a:avLst/>
              </a:prstGeom>
            </p:spPr>
          </p:pic>
        </p:grpSp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73754" y="1364775"/>
              <a:ext cx="1983725" cy="310814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1364693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687773" y="5826132"/>
            <a:ext cx="9144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S5</a:t>
            </a:r>
            <a:r>
              <a:rPr lang="zh-CN" alt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enotyping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Slc27a2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knockout generated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CRISPR/CAS9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DNA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equencing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result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howed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here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st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Slc27a2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ndicating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Slc27a2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gene reading frame was disrupted and abnormally stopped.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6979" y="189930"/>
            <a:ext cx="10865893" cy="54329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74174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114566" y="5399061"/>
            <a:ext cx="10322257" cy="1338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S6 a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No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ignificant alteration in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reatinine secretion in 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oledronate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-treated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Slc27a2</a:t>
            </a:r>
            <a:r>
              <a:rPr lang="en-US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ice compared with untreated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Slc27a2</a:t>
            </a:r>
            <a:r>
              <a:rPr lang="en-US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nes for 4-week (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ffect of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zoledronate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reatment on inflammatio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markers.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/>
              <a:t>Fibrosis quantification </a:t>
            </a:r>
            <a:r>
              <a:rPr lang="en-US" dirty="0" smtClean="0"/>
              <a:t>using Masson’s staining.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350" dirty="0" smtClean="0"/>
          </a:p>
          <a:p>
            <a:endParaRPr lang="en-US" sz="1350" b="1" dirty="0"/>
          </a:p>
        </p:txBody>
      </p:sp>
      <p:grpSp>
        <p:nvGrpSpPr>
          <p:cNvPr id="12" name="组合 11"/>
          <p:cNvGrpSpPr/>
          <p:nvPr/>
        </p:nvGrpSpPr>
        <p:grpSpPr>
          <a:xfrm>
            <a:off x="723349" y="920503"/>
            <a:ext cx="10877248" cy="4253308"/>
            <a:chOff x="723349" y="920503"/>
            <a:chExt cx="10877248" cy="4253308"/>
          </a:xfrm>
        </p:grpSpPr>
        <p:grpSp>
          <p:nvGrpSpPr>
            <p:cNvPr id="2" name="组合 1"/>
            <p:cNvGrpSpPr/>
            <p:nvPr/>
          </p:nvGrpSpPr>
          <p:grpSpPr>
            <a:xfrm>
              <a:off x="723349" y="920503"/>
              <a:ext cx="7697375" cy="3391135"/>
              <a:chOff x="614167" y="865912"/>
              <a:chExt cx="7697375" cy="3391135"/>
            </a:xfrm>
          </p:grpSpPr>
          <p:pic>
            <p:nvPicPr>
              <p:cNvPr id="5" name="图片 4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52905" y="1701381"/>
                <a:ext cx="2461117" cy="2555666"/>
              </a:xfrm>
              <a:prstGeom prst="rect">
                <a:avLst/>
              </a:prstGeom>
            </p:spPr>
          </p:pic>
          <p:sp>
            <p:nvSpPr>
              <p:cNvPr id="7" name="Rectangle 2"/>
              <p:cNvSpPr/>
              <p:nvPr/>
            </p:nvSpPr>
            <p:spPr>
              <a:xfrm>
                <a:off x="3889949" y="889817"/>
                <a:ext cx="372668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2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 </a:t>
                </a:r>
                <a:endParaRPr lang="en-US" sz="2400" dirty="0"/>
              </a:p>
            </p:txBody>
          </p:sp>
          <p:sp>
            <p:nvSpPr>
              <p:cNvPr id="8" name="Rectangle 7"/>
              <p:cNvSpPr/>
              <p:nvPr/>
            </p:nvSpPr>
            <p:spPr>
              <a:xfrm>
                <a:off x="614167" y="865912"/>
                <a:ext cx="355837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2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 </a:t>
                </a:r>
                <a:endParaRPr lang="en-US" sz="2400" dirty="0"/>
              </a:p>
            </p:txBody>
          </p:sp>
          <p:sp>
            <p:nvSpPr>
              <p:cNvPr id="9" name="Rectangle 9"/>
              <p:cNvSpPr/>
              <p:nvPr/>
            </p:nvSpPr>
            <p:spPr>
              <a:xfrm>
                <a:off x="7955705" y="878960"/>
                <a:ext cx="355837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2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 </a:t>
                </a:r>
                <a:endParaRPr lang="en-US" sz="2400" dirty="0"/>
              </a:p>
            </p:txBody>
          </p:sp>
        </p:grpSp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31057" y="1120798"/>
              <a:ext cx="3050570" cy="3550079"/>
            </a:xfrm>
            <a:prstGeom prst="rect">
              <a:avLst/>
            </a:prstGeom>
          </p:spPr>
        </p:pic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52680" y="1027881"/>
              <a:ext cx="2947917" cy="414593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7028195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7630637" y="699879"/>
            <a:ext cx="4424885" cy="517064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7 a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Relative protein levels related to small </a:t>
            </a: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TPases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. All relative levels of proteins were </a:t>
            </a: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ole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treated cells compared with the ones in controls and data presented as mean ± SD (each treated sample (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n=2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 was compared with each untreated one (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n=2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 once, resulting 4 sets of data).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ole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disrupted the arrangement and morphology of F-actin in HK-2 cells (scale bar: 20 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Western blotting of Membrane and cytoplasmic fractions for 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hoA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family. 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ole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up-regulated cytosolic Rho 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TPase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but decreased the ones in membrane. 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zh-CN" alt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ole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treatments resulted in higher GTP binding 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hoA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family proteins</a:t>
            </a:r>
            <a:r>
              <a:rPr lang="zh-CN" alt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zh-CN" altLang="zh-CN" sz="2400" dirty="0" smtClean="0"/>
              <a:t> 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ole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acid induces ROCK, 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filin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and NOX4 activity.</a:t>
            </a:r>
            <a:r>
              <a:rPr lang="zh-CN" alt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912" y="0"/>
            <a:ext cx="7309821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7178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26267" y="5299473"/>
            <a:ext cx="1118351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S8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Up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regulations of ROS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production.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OS levels in the samples of HK-2 cell treated with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Zole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at doses of 0, 1, 10, 50 µM for 6 h. ROS production were assessed by ﬂow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analysis. The arrow indicated the peaks of represented ROS contents.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elative levels of metabolites in the pathway of cysteine-mediated GSH biosynthesis in control and 50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Zole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treated samples. </a:t>
            </a: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729" y="797178"/>
            <a:ext cx="5027475" cy="3619659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4322" y="934269"/>
            <a:ext cx="4673617" cy="4205899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464024" y="573211"/>
            <a:ext cx="579517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a                                                              b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23364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92</TotalTime>
  <Words>476</Words>
  <Application>Microsoft Office PowerPoint</Application>
  <PresentationFormat>宽屏</PresentationFormat>
  <Paragraphs>19</Paragraphs>
  <Slides>8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3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li cheng</dc:creator>
  <cp:lastModifiedBy>lili cheng</cp:lastModifiedBy>
  <cp:revision>49</cp:revision>
  <cp:lastPrinted>2017-06-04T14:06:27Z</cp:lastPrinted>
  <dcterms:created xsi:type="dcterms:W3CDTF">2017-06-04T13:13:30Z</dcterms:created>
  <dcterms:modified xsi:type="dcterms:W3CDTF">2017-09-01T13:32:01Z</dcterms:modified>
</cp:coreProperties>
</file>